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6" autoAdjust="0"/>
    <p:restoredTop sz="94660"/>
  </p:normalViewPr>
  <p:slideViewPr>
    <p:cSldViewPr snapToGrid="0">
      <p:cViewPr varScale="1">
        <p:scale>
          <a:sx n="97" d="100"/>
          <a:sy n="97" d="100"/>
        </p:scale>
        <p:origin x="6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w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w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w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4BE4D7-2281-4757-9978-E03830DE86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667EC7-E0A3-4960-8233-37DFAE40B2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75CA64-1118-46B3-B29A-D9D4FDBAC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AD429F-9F4A-45A8-9A37-241A6B10BB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80EA01-613E-453F-B8E7-9041FF3AFD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21490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CA68E6-DDA3-48A4-A3DB-3813277EAE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5DBBA1-6EF9-40A1-B5B8-1FB95AA8A7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ECED1E-6822-4F49-9B1B-7C207AC650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E048D0-324E-489A-9D22-14633E804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7334EF-B88F-4FF5-B862-AFDAAC0A1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28421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D80D8F-1BE4-4BA8-9438-300826725B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05EFCE-516F-4363-B518-642B65276D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C05F41-0DC2-43E0-A5C0-CB04950C5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3DB890-F1DE-4F04-A491-A89CAD166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B30318-0AD9-4ECA-A999-1DC5E4D0A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47079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6A8C02-D292-4FFE-9DF9-BDEF5F6592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137C17-B736-4264-8792-71F95D5C1C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53CAF1-5B75-495D-A0EB-DBBA141BF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22A325-95E8-4E14-8862-D7044D36E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8EFD2F-0A55-48DB-957B-1EC54F61B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55855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4BDEE-D93F-45E8-AA48-5444CEDEAE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2F8B19-0366-43F1-9F47-7FE3822346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F2634D-7982-4964-AECE-9810E09D4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176651-5E64-428B-9A75-25956DF76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FE5806-D433-49B3-979C-2A3AC3B69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1311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B7B65F-E600-45AD-919C-65F3674FEC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110402-FA13-446C-9E99-8AE90EBECB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EA82A8-2C21-4C06-9B53-9C26FFAC44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969271-28D7-4421-9829-9728795CB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BAEC31-7940-4CD2-BF75-246D45376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DB7D82-BB42-4457-9ABA-C8593A410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8990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6ECB72-611F-494B-8957-E04E631F02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5BC82B-7CEC-4958-B62F-3D42A3FA17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677EB2-18D8-4A27-8152-ED3442F9E4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948949-8EC5-485B-8E7D-EA9B897577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9BF456-A4B9-4934-A470-697DC52F89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B3E646-90B3-4C48-83A9-73933A23C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E30A86D-87E8-45A3-B910-96086FDD8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E0A4E6-A34F-4D1C-B0E8-07206C0EF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75159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B28F0D-39BA-4CE3-8B81-27FB8F1B6E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FAD1A1-232B-4E1B-B271-67AEA8DE4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7A15124-2169-4CBC-B92B-F41213748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CC33AA-CC01-45A3-BC80-2F9C90F39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2206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13314C-E39D-4897-9EF0-53C4E89B9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58C920-0642-4A96-A9C2-8EBE97E09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C518F23-9B44-4276-8568-964116CDF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3046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5F07A7-B8AF-4100-805C-FF360189AD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7B5529-F9A3-49D3-8776-C0884CE490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540B58-D134-47AD-9305-36A5E1D955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48EA3C-DF57-4161-A1DB-67145397B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7ED7C6-0A43-4D1D-A822-914138852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6C971D-46A3-4E21-BACB-6D23459E0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91787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277128-20BB-44EA-B29C-F50053DF50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3B53DB9-250F-4B40-9627-FCF4F617D3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82D59F-46D9-4B6B-863D-1B21D7181E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D777D8-18D4-4FF9-B64D-4993B1F4AA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4E59B3-4B48-4DA7-901D-EDF99A34E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F49763-B1BF-4F40-9365-1FB1F5551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7399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23A4A2-8BF7-484F-AC66-BA370E5B59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FDFB00-FEA7-491D-AF91-8DF38C51F1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4487B7-34D4-4F93-8C1F-C21E7733FB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76440-2DF4-4375-8087-59FE8EC8CB94}" type="datetimeFigureOut">
              <a:rPr lang="en-AU" smtClean="0"/>
              <a:t>1/06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268E9E-D22B-4AED-A450-6E66E452A1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9D1A33-36DC-45C3-A14B-E590E33259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13CDB7-EE6B-4B71-8086-C884C7593F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142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w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3.w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5.wmf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7.wmf"/><Relationship Id="rId4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9.wmf"/><Relationship Id="rId4" Type="http://schemas.openxmlformats.org/officeDocument/2006/relationships/oleObject" Target="../embeddings/oleObject5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5" Type="http://schemas.openxmlformats.org/officeDocument/2006/relationships/image" Target="../media/image11.wmf"/><Relationship Id="rId4" Type="http://schemas.openxmlformats.org/officeDocument/2006/relationships/oleObject" Target="../embeddings/oleObject6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5" Type="http://schemas.openxmlformats.org/officeDocument/2006/relationships/image" Target="../media/image13.wmf"/><Relationship Id="rId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3484076E-DE41-4553-9AC9-C27CB70E477D}"/>
              </a:ext>
            </a:extLst>
          </p:cNvPr>
          <p:cNvGrpSpPr/>
          <p:nvPr/>
        </p:nvGrpSpPr>
        <p:grpSpPr>
          <a:xfrm>
            <a:off x="1992630" y="563245"/>
            <a:ext cx="8206740" cy="5731510"/>
            <a:chOff x="1992630" y="563245"/>
            <a:chExt cx="8206740" cy="573151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508F4DE-0E63-4B9B-8AB7-4125B80638CC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2630" y="563245"/>
              <a:ext cx="8206740" cy="5731510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C89776C4-3291-4525-816D-97215410060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16458648"/>
                </p:ext>
              </p:extLst>
            </p:nvPr>
          </p:nvGraphicFramePr>
          <p:xfrm>
            <a:off x="2603500" y="2531745"/>
            <a:ext cx="1622425" cy="936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3" name="CS ChemDraw Drawing" r:id="rId4" imgW="1631160" imgH="943920" progId="ChemDraw.Document.6.0">
                    <p:embed/>
                  </p:oleObj>
                </mc:Choice>
                <mc:Fallback>
                  <p:oleObj name="CS ChemDraw Drawing" r:id="rId4" imgW="1631160" imgH="943920" progId="ChemDraw.Document.6.0">
                    <p:embed/>
                    <p:pic>
                      <p:nvPicPr>
                        <p:cNvPr id="0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603500" y="2531745"/>
                          <a:ext cx="1622425" cy="9366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B73D9896-4475-4B2D-961B-668FED1E8480}"/>
              </a:ext>
            </a:extLst>
          </p:cNvPr>
          <p:cNvSpPr txBox="1"/>
          <p:nvPr/>
        </p:nvSpPr>
        <p:spPr>
          <a:xfrm>
            <a:off x="2268071" y="6332145"/>
            <a:ext cx="7655858" cy="281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AU" sz="1200" b="1" baseline="300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AU" sz="12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(500 MHz) for</a:t>
            </a:r>
            <a:r>
              <a:rPr lang="en-AU" sz="1200" b="1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nguinarine recorded in DMSO-</a:t>
            </a:r>
            <a:r>
              <a:rPr lang="en-AU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AU" sz="12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9762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AB829C85-373F-401D-862C-E04D6FEC6E34}"/>
              </a:ext>
            </a:extLst>
          </p:cNvPr>
          <p:cNvGrpSpPr/>
          <p:nvPr/>
        </p:nvGrpSpPr>
        <p:grpSpPr>
          <a:xfrm>
            <a:off x="2255520" y="747713"/>
            <a:ext cx="7680960" cy="5362575"/>
            <a:chOff x="2255520" y="747713"/>
            <a:chExt cx="7680960" cy="536257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602333A-5DBA-4B43-A1B3-78039D75DB5A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55520" y="747713"/>
              <a:ext cx="7680960" cy="5362575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25D55CC2-A8AA-4844-AE0B-405E639AD70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36096683"/>
                </p:ext>
              </p:extLst>
            </p:nvPr>
          </p:nvGraphicFramePr>
          <p:xfrm>
            <a:off x="2719388" y="2489200"/>
            <a:ext cx="1752600" cy="101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7" name="CS ChemDraw Drawing" r:id="rId4" imgW="1756800" imgH="1018440" progId="ChemDraw.Document.6.0">
                    <p:embed/>
                  </p:oleObj>
                </mc:Choice>
                <mc:Fallback>
                  <p:oleObj name="CS ChemDraw Drawing" r:id="rId4" imgW="1756800" imgH="1018440" progId="ChemDraw.Document.6.0">
                    <p:embed/>
                    <p:pic>
                      <p:nvPicPr>
                        <p:cNvPr id="0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719388" y="2489200"/>
                          <a:ext cx="1752600" cy="10128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CD08CA7D-AEF2-4CD1-9906-10019CC9192E}"/>
              </a:ext>
            </a:extLst>
          </p:cNvPr>
          <p:cNvSpPr txBox="1"/>
          <p:nvPr/>
        </p:nvSpPr>
        <p:spPr>
          <a:xfrm>
            <a:off x="2280622" y="6269392"/>
            <a:ext cx="7655858" cy="281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AU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NMR spectrum (500 MHz) for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elerythrine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orded in DMSO-</a:t>
            </a:r>
            <a:r>
              <a:rPr lang="en-AU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AU" sz="12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01497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8FD147BF-34D0-4713-A53B-42B57AE08E4B}"/>
              </a:ext>
            </a:extLst>
          </p:cNvPr>
          <p:cNvGrpSpPr/>
          <p:nvPr/>
        </p:nvGrpSpPr>
        <p:grpSpPr>
          <a:xfrm>
            <a:off x="1992630" y="563245"/>
            <a:ext cx="8206740" cy="5731510"/>
            <a:chOff x="1992630" y="563245"/>
            <a:chExt cx="8206740" cy="573151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FA4BA3E-4E41-43DA-BDEA-1878AFD88F32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2630" y="563245"/>
              <a:ext cx="8206740" cy="5731510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BA3534CD-662A-4D15-AF20-62CB4D20CE1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41470380"/>
                </p:ext>
              </p:extLst>
            </p:nvPr>
          </p:nvGraphicFramePr>
          <p:xfrm>
            <a:off x="2430463" y="2508250"/>
            <a:ext cx="1776412" cy="101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81" name="CS ChemDraw Drawing" r:id="rId4" imgW="1783440" imgH="1018440" progId="ChemDraw.Document.6.0">
                    <p:embed/>
                  </p:oleObj>
                </mc:Choice>
                <mc:Fallback>
                  <p:oleObj name="CS ChemDraw Drawing" r:id="rId4" imgW="1783440" imgH="1018440" progId="ChemDraw.Document.6.0">
                    <p:embed/>
                    <p:pic>
                      <p:nvPicPr>
                        <p:cNvPr id="0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430463" y="2508250"/>
                          <a:ext cx="1776412" cy="10128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A6BB935F-1C74-40AB-B3E7-D78F4707C0C8}"/>
              </a:ext>
            </a:extLst>
          </p:cNvPr>
          <p:cNvSpPr txBox="1"/>
          <p:nvPr/>
        </p:nvSpPr>
        <p:spPr>
          <a:xfrm>
            <a:off x="2280622" y="6269392"/>
            <a:ext cx="7655858" cy="281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AU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NMR spectrum (500 MHz) for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nguilutine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orded in DMSO-</a:t>
            </a:r>
            <a:r>
              <a:rPr lang="en-AU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AU" sz="12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11958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82F80C2C-7675-4C11-B929-944725EE979D}"/>
              </a:ext>
            </a:extLst>
          </p:cNvPr>
          <p:cNvGrpSpPr/>
          <p:nvPr/>
        </p:nvGrpSpPr>
        <p:grpSpPr>
          <a:xfrm>
            <a:off x="1992630" y="563245"/>
            <a:ext cx="8206740" cy="5731510"/>
            <a:chOff x="1992630" y="563245"/>
            <a:chExt cx="8206740" cy="573151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837B34E-B01E-4A3A-B978-64928EF6F26B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2630" y="563245"/>
              <a:ext cx="8206740" cy="5731510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77040E66-BD71-4014-B100-9A5F42AACF8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84414488"/>
                </p:ext>
              </p:extLst>
            </p:nvPr>
          </p:nvGraphicFramePr>
          <p:xfrm>
            <a:off x="2520950" y="2365375"/>
            <a:ext cx="1606550" cy="936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05" name="CS ChemDraw Drawing" r:id="rId4" imgW="1614960" imgH="943920" progId="ChemDraw.Document.6.0">
                    <p:embed/>
                  </p:oleObj>
                </mc:Choice>
                <mc:Fallback>
                  <p:oleObj name="CS ChemDraw Drawing" r:id="rId4" imgW="1614960" imgH="943920" progId="ChemDraw.Document.6.0">
                    <p:embed/>
                    <p:pic>
                      <p:nvPicPr>
                        <p:cNvPr id="0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20950" y="2365375"/>
                          <a:ext cx="1606550" cy="9366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EB6E3690-7670-4B08-8B31-F1CAAC1D7E65}"/>
              </a:ext>
            </a:extLst>
          </p:cNvPr>
          <p:cNvSpPr txBox="1"/>
          <p:nvPr/>
        </p:nvSpPr>
        <p:spPr>
          <a:xfrm>
            <a:off x="2280622" y="6269392"/>
            <a:ext cx="7655858" cy="281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AU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NMR spectrum (500 MHz) for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elirubine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orded in DMSO-</a:t>
            </a:r>
            <a:r>
              <a:rPr lang="en-AU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AU" sz="12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57482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B662F617-6AA7-41B7-B5D8-BC6A6CECC756}"/>
              </a:ext>
            </a:extLst>
          </p:cNvPr>
          <p:cNvGrpSpPr/>
          <p:nvPr/>
        </p:nvGrpSpPr>
        <p:grpSpPr>
          <a:xfrm>
            <a:off x="1992630" y="563245"/>
            <a:ext cx="8206740" cy="5731510"/>
            <a:chOff x="1992630" y="563245"/>
            <a:chExt cx="8206740" cy="573151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534F76F-3AAD-49E1-A7F9-4444C19B082B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2630" y="563245"/>
              <a:ext cx="8206740" cy="5731510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5EB9CE2C-FCAF-4A2C-AE7C-D7E32F54512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47226813"/>
                </p:ext>
              </p:extLst>
            </p:nvPr>
          </p:nvGraphicFramePr>
          <p:xfrm>
            <a:off x="2281238" y="2698750"/>
            <a:ext cx="1752600" cy="101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29" name="CS ChemDraw Drawing" r:id="rId4" imgW="1756800" imgH="1018440" progId="ChemDraw.Document.6.0">
                    <p:embed/>
                  </p:oleObj>
                </mc:Choice>
                <mc:Fallback>
                  <p:oleObj name="CS ChemDraw Drawing" r:id="rId4" imgW="1756800" imgH="1018440" progId="ChemDraw.Document.6.0">
                    <p:embed/>
                    <p:pic>
                      <p:nvPicPr>
                        <p:cNvPr id="0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281238" y="2698750"/>
                          <a:ext cx="1752600" cy="10128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38D933C4-222F-40D5-942A-43AD21976524}"/>
              </a:ext>
            </a:extLst>
          </p:cNvPr>
          <p:cNvSpPr txBox="1"/>
          <p:nvPr/>
        </p:nvSpPr>
        <p:spPr>
          <a:xfrm>
            <a:off x="2280622" y="6269392"/>
            <a:ext cx="7655858" cy="281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AU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NMR spectrum (500 MHz) for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elilutine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orded in CDCl</a:t>
            </a:r>
            <a:r>
              <a:rPr lang="en-AU" sz="12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80314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00D33998-0F9C-4B70-910C-97DD957B40D5}"/>
              </a:ext>
            </a:extLst>
          </p:cNvPr>
          <p:cNvGrpSpPr/>
          <p:nvPr/>
        </p:nvGrpSpPr>
        <p:grpSpPr>
          <a:xfrm>
            <a:off x="1992630" y="563245"/>
            <a:ext cx="8206740" cy="5731510"/>
            <a:chOff x="1992630" y="563245"/>
            <a:chExt cx="8206740" cy="573151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91B5F66-7BFC-453B-A28B-F7122607FA37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2630" y="563245"/>
              <a:ext cx="8206740" cy="5731510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AA5ECFBD-61B4-47D9-A227-BD0AF6D7D62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66032375"/>
                </p:ext>
              </p:extLst>
            </p:nvPr>
          </p:nvGraphicFramePr>
          <p:xfrm>
            <a:off x="2290763" y="2416175"/>
            <a:ext cx="4113212" cy="101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76" name="CS ChemDraw Drawing" r:id="rId4" imgW="4111200" imgH="1019880" progId="ChemDraw.Document.6.0">
                    <p:embed/>
                  </p:oleObj>
                </mc:Choice>
                <mc:Fallback>
                  <p:oleObj name="CS ChemDraw Drawing" r:id="rId4" imgW="4111200" imgH="1019880" progId="ChemDraw.Document.6.0">
                    <p:embed/>
                    <p:pic>
                      <p:nvPicPr>
                        <p:cNvPr id="0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290763" y="2416175"/>
                          <a:ext cx="4113212" cy="10128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01AA4808-0684-4AA6-9207-61E06EF98492}"/>
              </a:ext>
            </a:extLst>
          </p:cNvPr>
          <p:cNvSpPr txBox="1"/>
          <p:nvPr/>
        </p:nvSpPr>
        <p:spPr>
          <a:xfrm>
            <a:off x="2280622" y="6269392"/>
            <a:ext cx="7655858" cy="281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AU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NMR spectrum (500 MHz) for protopine recorded in DMSO-</a:t>
            </a:r>
            <a:r>
              <a:rPr lang="en-AU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AU" sz="12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90972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C3202247-05DE-4B4B-9DA8-4B7D8FDAA6A3}"/>
              </a:ext>
            </a:extLst>
          </p:cNvPr>
          <p:cNvGrpSpPr/>
          <p:nvPr/>
        </p:nvGrpSpPr>
        <p:grpSpPr>
          <a:xfrm>
            <a:off x="1992630" y="563245"/>
            <a:ext cx="8206740" cy="5731510"/>
            <a:chOff x="1992630" y="563245"/>
            <a:chExt cx="8206740" cy="573151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9E14C30-FEAD-41A8-AA0B-0D3FAA57B7B5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2630" y="563245"/>
              <a:ext cx="8206740" cy="5731510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017C95F3-E54D-4C54-B965-8C0AC0D0D12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34891599"/>
                </p:ext>
              </p:extLst>
            </p:nvPr>
          </p:nvGraphicFramePr>
          <p:xfrm>
            <a:off x="2368550" y="2317750"/>
            <a:ext cx="4130675" cy="10112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200" name="CS ChemDraw Drawing" r:id="rId4" imgW="4137480" imgH="1019880" progId="ChemDraw.Document.6.0">
                    <p:embed/>
                  </p:oleObj>
                </mc:Choice>
                <mc:Fallback>
                  <p:oleObj name="CS ChemDraw Drawing" r:id="rId4" imgW="4137480" imgH="1019880" progId="ChemDraw.Document.6.0">
                    <p:embed/>
                    <p:pic>
                      <p:nvPicPr>
                        <p:cNvPr id="0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368550" y="2317750"/>
                          <a:ext cx="4130675" cy="10112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45134E31-36FD-475F-93DA-C90D6153D954}"/>
              </a:ext>
            </a:extLst>
          </p:cNvPr>
          <p:cNvSpPr txBox="1"/>
          <p:nvPr/>
        </p:nvSpPr>
        <p:spPr>
          <a:xfrm>
            <a:off x="2280622" y="6269392"/>
            <a:ext cx="7655858" cy="281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AU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NMR spectrum (500 MHz) for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locrytopine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orded in DMSO-</a:t>
            </a:r>
            <a:r>
              <a:rPr lang="en-AU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AU" sz="12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2864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Widescreen</PresentationFormat>
  <Paragraphs>7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Carroll</dc:creator>
  <cp:lastModifiedBy>Andrew Croaker</cp:lastModifiedBy>
  <cp:revision>6</cp:revision>
  <dcterms:created xsi:type="dcterms:W3CDTF">2022-05-29T10:08:53Z</dcterms:created>
  <dcterms:modified xsi:type="dcterms:W3CDTF">2022-06-01T12:06:58Z</dcterms:modified>
</cp:coreProperties>
</file>